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17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3K_RGY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1750" y="412750"/>
            <a:ext cx="3429000" cy="3429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5BFFB33-3F64-3D28-AAE7-4292A832F5E0}"/>
              </a:ext>
            </a:extLst>
          </p:cNvPr>
          <p:cNvSpPr txBox="1"/>
          <p:nvPr/>
        </p:nvSpPr>
        <p:spPr>
          <a:xfrm>
            <a:off x="812800" y="4318000"/>
            <a:ext cx="5372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: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enotypic distribution of ratio of grain yield per plant between low nitrogen condition and normal nitrogen condition (RGY) in 284 germplasm resources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8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来圆 翟</dc:creator>
  <cp:lastModifiedBy>MDPI</cp:lastModifiedBy>
  <cp:revision>7</cp:revision>
  <dcterms:created xsi:type="dcterms:W3CDTF">2025-02-10T09:02:00Z</dcterms:created>
  <dcterms:modified xsi:type="dcterms:W3CDTF">2025-06-16T01:36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AD749D059FF4BCFAC69DF872651B026_12</vt:lpwstr>
  </property>
  <property fmtid="{D5CDD505-2E9C-101B-9397-08002B2CF9AE}" pid="3" name="KSOProductBuildVer">
    <vt:lpwstr>2052-12.1.0.20784</vt:lpwstr>
  </property>
</Properties>
</file>